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45" d="100"/>
          <a:sy n="45" d="100"/>
        </p:scale>
        <p:origin x="-2424" y="-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9532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5674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3577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53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046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072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521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633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6942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8091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13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B4DBB-038B-4073-AE4C-A1B958769465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E4BA8-52A7-49D9-B3CC-BDF397E91D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7115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1921229"/>
            <a:ext cx="6799584" cy="7757052"/>
            <a:chOff x="0" y="1921229"/>
            <a:chExt cx="6799584" cy="775705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382910"/>
              <a:ext cx="3490044" cy="291374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0" y="1921229"/>
              <a:ext cx="27206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Leave One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t analysis: Birth weight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6632" y="6173005"/>
              <a:ext cx="3373412" cy="2256619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0" y="5668950"/>
              <a:ext cx="2424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 Leave One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t analysis: LG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11972" y="1921229"/>
              <a:ext cx="27077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Leave One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t analysis: Macrosomi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90044" y="2313357"/>
              <a:ext cx="3309540" cy="2983292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511972" y="5665750"/>
              <a:ext cx="2183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ave one out analysis: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A</a:t>
              </a:r>
              <a:endParaRPr lang="en-GB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621980" y="6173006"/>
              <a:ext cx="3177604" cy="2256618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16632" y="9416671"/>
              <a:ext cx="27077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 Fig: Leave One Out sensitivity analysis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20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6</TotalTime>
  <Words>41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Windows User</cp:lastModifiedBy>
  <cp:revision>26</cp:revision>
  <cp:lastPrinted>2019-05-01T07:39:09Z</cp:lastPrinted>
  <dcterms:created xsi:type="dcterms:W3CDTF">2019-01-31T07:44:23Z</dcterms:created>
  <dcterms:modified xsi:type="dcterms:W3CDTF">2019-06-08T18:38:25Z</dcterms:modified>
</cp:coreProperties>
</file>